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09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Lab\PhD\Transcriptome%20Analysis\Against%20Supertranscripts%20200bp%20more\TF%20analysis\Real%20time%20PCR%20results%20TF%20analysis\Resul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Lab\PhD\Transcriptome%20Analysis\Against%20Supertranscripts%20200bp%20more\TF%20analysis\Real%20time%20PCR%20results%20TF%20analysis\Result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Lab\PhD\Transcriptome%20Analysis\Against%20Supertranscripts%20200bp%20more\TF%20analysis\Real%20time%20PCR%20results%20TF%20analysis\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6"/>
  <c:chart>
    <c:view3D>
      <c:rAngAx val="1"/>
    </c:view3D>
    <c:plotArea>
      <c:layout/>
      <c:bar3DChart>
        <c:barDir val="col"/>
        <c:grouping val="clustered"/>
        <c:ser>
          <c:idx val="0"/>
          <c:order val="0"/>
          <c:cat>
            <c:strRef>
              <c:f>Results!$B$67:$B$72</c:f>
              <c:strCache>
                <c:ptCount val="6"/>
                <c:pt idx="0">
                  <c:v>CDPK VM</c:v>
                </c:pt>
                <c:pt idx="1">
                  <c:v>CDPK VF</c:v>
                </c:pt>
                <c:pt idx="2">
                  <c:v>CDPK IMM</c:v>
                </c:pt>
                <c:pt idx="3">
                  <c:v>CDPK IMF</c:v>
                </c:pt>
                <c:pt idx="4">
                  <c:v>CDPK MM</c:v>
                </c:pt>
                <c:pt idx="5">
                  <c:v>CDPK MF</c:v>
                </c:pt>
              </c:strCache>
            </c:strRef>
          </c:cat>
          <c:val>
            <c:numRef>
              <c:f>Results!$F$67:$F$72</c:f>
              <c:numCache>
                <c:formatCode>0.00E+00</c:formatCode>
                <c:ptCount val="6"/>
                <c:pt idx="0">
                  <c:v>1.8860000000000002E-5</c:v>
                </c:pt>
                <c:pt idx="1">
                  <c:v>7.1870000000000017E-6</c:v>
                </c:pt>
                <c:pt idx="2">
                  <c:v>2.6130000000000002E-5</c:v>
                </c:pt>
                <c:pt idx="3">
                  <c:v>7.2140000000000016E-6</c:v>
                </c:pt>
                <c:pt idx="4">
                  <c:v>9.2960000000000021E-6</c:v>
                </c:pt>
                <c:pt idx="5">
                  <c:v>1.6310000000000005E-5</c:v>
                </c:pt>
              </c:numCache>
            </c:numRef>
          </c:val>
        </c:ser>
        <c:shape val="box"/>
        <c:axId val="131445120"/>
        <c:axId val="131446656"/>
        <c:axId val="0"/>
      </c:bar3DChart>
      <c:catAx>
        <c:axId val="131445120"/>
        <c:scaling>
          <c:orientation val="minMax"/>
        </c:scaling>
        <c:axPos val="b"/>
        <c:tickLblPos val="nextTo"/>
        <c:crossAx val="131446656"/>
        <c:crosses val="autoZero"/>
        <c:auto val="1"/>
        <c:lblAlgn val="ctr"/>
        <c:lblOffset val="100"/>
      </c:catAx>
      <c:valAx>
        <c:axId val="131446656"/>
        <c:scaling>
          <c:orientation val="minMax"/>
        </c:scaling>
        <c:axPos val="l"/>
        <c:majorGridlines/>
        <c:numFmt formatCode="0.00E+00" sourceLinked="1"/>
        <c:tickLblPos val="nextTo"/>
        <c:crossAx val="131445120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style val="6"/>
  <c:chart>
    <c:view3D>
      <c:rAngAx val="1"/>
    </c:view3D>
    <c:plotArea>
      <c:layout/>
      <c:bar3DChart>
        <c:barDir val="col"/>
        <c:grouping val="clustered"/>
        <c:ser>
          <c:idx val="0"/>
          <c:order val="0"/>
          <c:cat>
            <c:strRef>
              <c:f>Results!$B$35:$B$40</c:f>
              <c:strCache>
                <c:ptCount val="6"/>
                <c:pt idx="0">
                  <c:v>ACT VM</c:v>
                </c:pt>
                <c:pt idx="1">
                  <c:v>ACT VF</c:v>
                </c:pt>
                <c:pt idx="2">
                  <c:v>ACT IMM</c:v>
                </c:pt>
                <c:pt idx="3">
                  <c:v>ACT IMF</c:v>
                </c:pt>
                <c:pt idx="4">
                  <c:v>ACT MM</c:v>
                </c:pt>
                <c:pt idx="5">
                  <c:v>ACT MF</c:v>
                </c:pt>
              </c:strCache>
            </c:strRef>
          </c:cat>
          <c:val>
            <c:numRef>
              <c:f>Results!$F$35:$F$40</c:f>
              <c:numCache>
                <c:formatCode>0.00E+00</c:formatCode>
                <c:ptCount val="6"/>
                <c:pt idx="0">
                  <c:v>3.6150000000000006E-4</c:v>
                </c:pt>
                <c:pt idx="1">
                  <c:v>3.4180000000000007E-4</c:v>
                </c:pt>
                <c:pt idx="2">
                  <c:v>6.4780000000000024E-4</c:v>
                </c:pt>
                <c:pt idx="3">
                  <c:v>1.8420000000000006E-4</c:v>
                </c:pt>
                <c:pt idx="4">
                  <c:v>2.8830000000000007E-4</c:v>
                </c:pt>
                <c:pt idx="5">
                  <c:v>3.9550000000000007E-4</c:v>
                </c:pt>
              </c:numCache>
            </c:numRef>
          </c:val>
        </c:ser>
        <c:shape val="box"/>
        <c:axId val="131478656"/>
        <c:axId val="131480192"/>
        <c:axId val="0"/>
      </c:bar3DChart>
      <c:catAx>
        <c:axId val="131478656"/>
        <c:scaling>
          <c:orientation val="minMax"/>
        </c:scaling>
        <c:axPos val="b"/>
        <c:tickLblPos val="nextTo"/>
        <c:crossAx val="131480192"/>
        <c:crosses val="autoZero"/>
        <c:auto val="1"/>
        <c:lblAlgn val="ctr"/>
        <c:lblOffset val="100"/>
      </c:catAx>
      <c:valAx>
        <c:axId val="131480192"/>
        <c:scaling>
          <c:orientation val="minMax"/>
        </c:scaling>
        <c:axPos val="l"/>
        <c:majorGridlines/>
        <c:numFmt formatCode="0.00E+00" sourceLinked="1"/>
        <c:tickLblPos val="nextTo"/>
        <c:crossAx val="131478656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style val="6"/>
  <c:chart>
    <c:view3D>
      <c:rAngAx val="1"/>
    </c:view3D>
    <c:plotArea>
      <c:layout/>
      <c:bar3DChart>
        <c:barDir val="col"/>
        <c:grouping val="clustered"/>
        <c:ser>
          <c:idx val="0"/>
          <c:order val="0"/>
          <c:cat>
            <c:strRef>
              <c:f>Results!$B$165:$B$170</c:f>
              <c:strCache>
                <c:ptCount val="6"/>
                <c:pt idx="0">
                  <c:v>1687 VM</c:v>
                </c:pt>
                <c:pt idx="1">
                  <c:v>1687 VF</c:v>
                </c:pt>
                <c:pt idx="2">
                  <c:v>1687 IMM</c:v>
                </c:pt>
                <c:pt idx="3">
                  <c:v>1687 IMF</c:v>
                </c:pt>
                <c:pt idx="4">
                  <c:v>1687 MM</c:v>
                </c:pt>
                <c:pt idx="5">
                  <c:v>1687 MF</c:v>
                </c:pt>
              </c:strCache>
            </c:strRef>
          </c:cat>
          <c:val>
            <c:numRef>
              <c:f>Results!$F$165:$F$170</c:f>
              <c:numCache>
                <c:formatCode>0.00E+00</c:formatCode>
                <c:ptCount val="6"/>
                <c:pt idx="0">
                  <c:v>5.9400000000000021E-5</c:v>
                </c:pt>
                <c:pt idx="1">
                  <c:v>5.9060000000000021E-5</c:v>
                </c:pt>
                <c:pt idx="2">
                  <c:v>6.5740000000000018E-5</c:v>
                </c:pt>
                <c:pt idx="3">
                  <c:v>6.2460000000000008E-5</c:v>
                </c:pt>
                <c:pt idx="4">
                  <c:v>5.1460000000000005E-5</c:v>
                </c:pt>
                <c:pt idx="5">
                  <c:v>6.1849999999999999E-5</c:v>
                </c:pt>
              </c:numCache>
            </c:numRef>
          </c:val>
        </c:ser>
        <c:shape val="box"/>
        <c:axId val="131565440"/>
        <c:axId val="131566976"/>
        <c:axId val="0"/>
      </c:bar3DChart>
      <c:catAx>
        <c:axId val="131565440"/>
        <c:scaling>
          <c:orientation val="minMax"/>
        </c:scaling>
        <c:axPos val="b"/>
        <c:tickLblPos val="nextTo"/>
        <c:crossAx val="131566976"/>
        <c:crosses val="autoZero"/>
        <c:auto val="1"/>
        <c:lblAlgn val="ctr"/>
        <c:lblOffset val="100"/>
      </c:catAx>
      <c:valAx>
        <c:axId val="131566976"/>
        <c:scaling>
          <c:orientation val="minMax"/>
        </c:scaling>
        <c:axPos val="l"/>
        <c:majorGridlines/>
        <c:numFmt formatCode="0.00E+00" sourceLinked="1"/>
        <c:tickLblPos val="nextTo"/>
        <c:crossAx val="131565440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F2CC9-7E80-4DE0-8840-191DA3BA96F9}" type="datetimeFigureOut">
              <a:rPr lang="en-AU" smtClean="0"/>
              <a:pPr/>
              <a:t>2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9C969D-9D66-4C67-BC20-ED1F6072101D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4788024" y="836712"/>
          <a:ext cx="3667125" cy="2076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971600" y="908720"/>
          <a:ext cx="3384376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3059832" y="3717032"/>
          <a:ext cx="3312368" cy="1944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51520" y="260648"/>
            <a:ext cx="20444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b="1" dirty="0" smtClean="0"/>
              <a:t>Reference transcripts:</a:t>
            </a:r>
            <a:endParaRPr lang="en-AU" sz="16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627784" y="5661248"/>
            <a:ext cx="44285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dirty="0" smtClean="0"/>
              <a:t> Locus_1687 – constitutively expressed transcript</a:t>
            </a:r>
            <a:endParaRPr lang="en-AU" sz="1600" dirty="0"/>
          </a:p>
        </p:txBody>
      </p:sp>
      <p:sp>
        <p:nvSpPr>
          <p:cNvPr id="9" name="TextBox 8"/>
          <p:cNvSpPr txBox="1"/>
          <p:nvPr/>
        </p:nvSpPr>
        <p:spPr>
          <a:xfrm>
            <a:off x="2339752" y="2852936"/>
            <a:ext cx="8398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i="1" dirty="0" smtClean="0"/>
              <a:t>Mp ACT</a:t>
            </a:r>
            <a:endParaRPr lang="en-AU" sz="16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6372200" y="2924944"/>
            <a:ext cx="9589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i="1" dirty="0" smtClean="0"/>
              <a:t>Mp CDPK</a:t>
            </a:r>
            <a:endParaRPr lang="en-AU" sz="1600" i="1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1733347" y="3316342"/>
            <a:ext cx="4896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dirty="0" smtClean="0"/>
              <a:t>Transcript </a:t>
            </a:r>
            <a:r>
              <a:rPr lang="en-AU" dirty="0" smtClean="0"/>
              <a:t>abundance</a:t>
            </a:r>
            <a:endParaRPr lang="en-AU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</TotalTime>
  <Words>1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iharika</dc:creator>
  <cp:lastModifiedBy>Niharika</cp:lastModifiedBy>
  <cp:revision>29</cp:revision>
  <dcterms:created xsi:type="dcterms:W3CDTF">2013-07-31T02:08:31Z</dcterms:created>
  <dcterms:modified xsi:type="dcterms:W3CDTF">2013-08-02T06:39:39Z</dcterms:modified>
</cp:coreProperties>
</file>